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E5FEC8-1438-47E3-874E-110ECD07DCC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ctangle 1031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73DBCF-C3D1-4965-B713-5035C2B6865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E638E-AB9D-4CC3-9B42-1048FDDF56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F33F7-C380-41BC-9313-268AA502E3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464620-5B23-416B-BEC9-012AE36C43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07625-DEBD-4B96-AB7F-F32C4C5E09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0C5849-8487-4529-9749-70B6D9D06E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BBC2C-AC90-4DA7-A39B-0B31EFBD0D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6A239-CFE9-4135-948B-60FBE56AA6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636ED-A1ED-4078-89A2-2FC8BF4131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42FC8-12BC-4CC2-9BAE-C4EDF86CA0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0C758-E672-4D3A-B766-2ECBC91469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5B6AD-26D0-4FF8-B3B8-94900AAF3B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E0D8F-8DA9-4B73-93C2-16E84F513A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7C6D1B-09CA-4CEA-9B7B-196BCA65579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75960" y="75960"/>
            <a:ext cx="6629400" cy="5331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: Induction of splenomegaly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PS hypersensitivity in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. acnes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rimed 3d mice (UNC93B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mic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5"/>
          <p:cNvSpPr/>
          <p:nvPr/>
        </p:nvSpPr>
        <p:spPr>
          <a:xfrm>
            <a:off x="122400" y="34257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18" descr=""/>
          <p:cNvPicPr/>
          <p:nvPr/>
        </p:nvPicPr>
        <p:blipFill>
          <a:blip r:embed="rId1"/>
          <a:stretch/>
        </p:blipFill>
        <p:spPr>
          <a:xfrm>
            <a:off x="338040" y="666720"/>
            <a:ext cx="2081160" cy="267480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14"/>
          <p:cNvSpPr/>
          <p:nvPr/>
        </p:nvSpPr>
        <p:spPr>
          <a:xfrm>
            <a:off x="122400" y="5335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20" descr=""/>
          <p:cNvPicPr/>
          <p:nvPr/>
        </p:nvPicPr>
        <p:blipFill>
          <a:blip r:embed="rId2"/>
          <a:stretch/>
        </p:blipFill>
        <p:spPr>
          <a:xfrm>
            <a:off x="2540160" y="666720"/>
            <a:ext cx="2070000" cy="26859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2" descr=""/>
          <p:cNvPicPr/>
          <p:nvPr/>
        </p:nvPicPr>
        <p:blipFill>
          <a:blip r:embed="rId3"/>
          <a:stretch/>
        </p:blipFill>
        <p:spPr>
          <a:xfrm>
            <a:off x="4672080" y="649440"/>
            <a:ext cx="2089080" cy="26841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6" descr=""/>
          <p:cNvPicPr/>
          <p:nvPr/>
        </p:nvPicPr>
        <p:blipFill>
          <a:blip r:embed="rId4"/>
          <a:stretch/>
        </p:blipFill>
        <p:spPr>
          <a:xfrm>
            <a:off x="285840" y="3706920"/>
            <a:ext cx="2152440" cy="253512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7" descr=""/>
          <p:cNvPicPr/>
          <p:nvPr/>
        </p:nvPicPr>
        <p:blipFill>
          <a:blip r:embed="rId5"/>
          <a:stretch/>
        </p:blipFill>
        <p:spPr>
          <a:xfrm>
            <a:off x="2422440" y="3716280"/>
            <a:ext cx="2149560" cy="25164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8" descr=""/>
          <p:cNvPicPr/>
          <p:nvPr/>
        </p:nvPicPr>
        <p:blipFill>
          <a:blip r:embed="rId6"/>
          <a:stretch/>
        </p:blipFill>
        <p:spPr>
          <a:xfrm>
            <a:off x="4581360" y="3738600"/>
            <a:ext cx="2143440" cy="24717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9" descr=""/>
          <p:cNvPicPr/>
          <p:nvPr/>
        </p:nvPicPr>
        <p:blipFill>
          <a:blip r:embed="rId7"/>
          <a:stretch/>
        </p:blipFill>
        <p:spPr>
          <a:xfrm>
            <a:off x="88920" y="6585120"/>
            <a:ext cx="2278080" cy="24685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0" descr=""/>
          <p:cNvPicPr/>
          <p:nvPr/>
        </p:nvPicPr>
        <p:blipFill>
          <a:blip r:embed="rId8"/>
          <a:stretch/>
        </p:blipFill>
        <p:spPr>
          <a:xfrm>
            <a:off x="2335320" y="6573960"/>
            <a:ext cx="2236680" cy="24685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31" descr=""/>
          <p:cNvPicPr/>
          <p:nvPr/>
        </p:nvPicPr>
        <p:blipFill>
          <a:blip r:embed="rId9"/>
          <a:stretch/>
        </p:blipFill>
        <p:spPr>
          <a:xfrm>
            <a:off x="4508640" y="6585120"/>
            <a:ext cx="2273040" cy="2468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3T02:37:38Z</dcterms:created>
  <dc:creator>mac165</dc:creator>
  <dc:description/>
  <dc:language>en-US</dc:language>
  <cp:lastModifiedBy>domis</cp:lastModifiedBy>
  <cp:lastPrinted>2011-01-11T23:27:35Z</cp:lastPrinted>
  <dcterms:modified xsi:type="dcterms:W3CDTF">2012-05-24T18:13:08Z</dcterms:modified>
  <cp:revision>345</cp:revision>
  <dc:subject/>
  <dc:title>PowerPoint Presentation</dc:title>
</cp:coreProperties>
</file>